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5" r:id="rId2"/>
  </p:sldIdLst>
  <p:sldSz cx="6858000" cy="9906000" type="A4"/>
  <p:notesSz cx="6800850" cy="99329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F00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381" autoAdjust="0"/>
    <p:restoredTop sz="95865" autoAdjust="0"/>
  </p:normalViewPr>
  <p:slideViewPr>
    <p:cSldViewPr snapToGrid="0">
      <p:cViewPr>
        <p:scale>
          <a:sx n="75" d="100"/>
          <a:sy n="75" d="100"/>
        </p:scale>
        <p:origin x="2678" y="-52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template!$H$41</c:f>
              <c:strCache>
                <c:ptCount val="1"/>
                <c:pt idx="0">
                  <c:v>f/f</c:v>
                </c:pt>
              </c:strCache>
            </c:strRef>
          </c:tx>
          <c:spPr>
            <a:ln w="63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emplate!$I$47:$Q$47</c:f>
                <c:numCache>
                  <c:formatCode>General</c:formatCode>
                  <c:ptCount val="9"/>
                  <c:pt idx="0">
                    <c:v>8.7931334817897202</c:v>
                  </c:pt>
                  <c:pt idx="1">
                    <c:v>28.242571716167369</c:v>
                  </c:pt>
                  <c:pt idx="2">
                    <c:v>30.30602839606102</c:v>
                  </c:pt>
                  <c:pt idx="4">
                    <c:v>15.476652923493688</c:v>
                  </c:pt>
                  <c:pt idx="8">
                    <c:v>33.175803359849908</c:v>
                  </c:pt>
                </c:numCache>
              </c:numRef>
            </c:plus>
            <c:minus>
              <c:numRef>
                <c:f>template!$I$47:$Q$47</c:f>
                <c:numCache>
                  <c:formatCode>General</c:formatCode>
                  <c:ptCount val="9"/>
                  <c:pt idx="0">
                    <c:v>8.7931334817897202</c:v>
                  </c:pt>
                  <c:pt idx="1">
                    <c:v>28.242571716167369</c:v>
                  </c:pt>
                  <c:pt idx="2">
                    <c:v>30.30602839606102</c:v>
                  </c:pt>
                  <c:pt idx="4">
                    <c:v>15.476652923493688</c:v>
                  </c:pt>
                  <c:pt idx="8">
                    <c:v>33.17580335984990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template!$I$40:$Q$40</c:f>
              <c:numCache>
                <c:formatCode>General</c:formatCode>
                <c:ptCount val="9"/>
                <c:pt idx="0">
                  <c:v>0</c:v>
                </c:pt>
                <c:pt idx="2">
                  <c:v>30</c:v>
                </c:pt>
                <c:pt idx="4">
                  <c:v>60</c:v>
                </c:pt>
                <c:pt idx="6">
                  <c:v>90</c:v>
                </c:pt>
                <c:pt idx="8">
                  <c:v>120</c:v>
                </c:pt>
              </c:numCache>
            </c:numRef>
          </c:cat>
          <c:val>
            <c:numRef>
              <c:f>template!$I$41:$Q$41</c:f>
              <c:numCache>
                <c:formatCode>General</c:formatCode>
                <c:ptCount val="9"/>
                <c:pt idx="0">
                  <c:v>111.625</c:v>
                </c:pt>
                <c:pt idx="1">
                  <c:v>458</c:v>
                </c:pt>
                <c:pt idx="2">
                  <c:v>532.25</c:v>
                </c:pt>
                <c:pt idx="4">
                  <c:v>359.75</c:v>
                </c:pt>
                <c:pt idx="8">
                  <c:v>197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FCC-45DF-A30E-0C32A4FFDF88}"/>
            </c:ext>
          </c:extLst>
        </c:ser>
        <c:ser>
          <c:idx val="1"/>
          <c:order val="1"/>
          <c:tx>
            <c:strRef>
              <c:f>template!$H$42</c:f>
              <c:strCache>
                <c:ptCount val="1"/>
                <c:pt idx="0">
                  <c:v>VeNKO</c:v>
                </c:pt>
              </c:strCache>
            </c:strRef>
          </c:tx>
          <c:spPr>
            <a:ln w="63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ysClr val="windowText" lastClr="000000"/>
              </a:solidFill>
              <a:ln w="63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emplate!$I$48:$Q$48</c:f>
                <c:numCache>
                  <c:formatCode>General</c:formatCode>
                  <c:ptCount val="9"/>
                  <c:pt idx="0">
                    <c:v>14.523773614319392</c:v>
                  </c:pt>
                  <c:pt idx="1">
                    <c:v>31.32315437499873</c:v>
                  </c:pt>
                  <c:pt idx="2">
                    <c:v>27.087635555729111</c:v>
                  </c:pt>
                  <c:pt idx="4">
                    <c:v>63.737430133321162</c:v>
                  </c:pt>
                  <c:pt idx="8">
                    <c:v>32.561326754295486</c:v>
                  </c:pt>
                </c:numCache>
              </c:numRef>
            </c:plus>
            <c:minus>
              <c:numRef>
                <c:f>template!$I$48:$Q$48</c:f>
                <c:numCache>
                  <c:formatCode>General</c:formatCode>
                  <c:ptCount val="9"/>
                  <c:pt idx="0">
                    <c:v>14.523773614319392</c:v>
                  </c:pt>
                  <c:pt idx="1">
                    <c:v>31.32315437499873</c:v>
                  </c:pt>
                  <c:pt idx="2">
                    <c:v>27.087635555729111</c:v>
                  </c:pt>
                  <c:pt idx="4">
                    <c:v>63.737430133321162</c:v>
                  </c:pt>
                  <c:pt idx="8">
                    <c:v>32.561326754295486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template!$I$40:$Q$40</c:f>
              <c:numCache>
                <c:formatCode>General</c:formatCode>
                <c:ptCount val="9"/>
                <c:pt idx="0">
                  <c:v>0</c:v>
                </c:pt>
                <c:pt idx="2">
                  <c:v>30</c:v>
                </c:pt>
                <c:pt idx="4">
                  <c:v>60</c:v>
                </c:pt>
                <c:pt idx="6">
                  <c:v>90</c:v>
                </c:pt>
                <c:pt idx="8">
                  <c:v>120</c:v>
                </c:pt>
              </c:numCache>
            </c:numRef>
          </c:cat>
          <c:val>
            <c:numRef>
              <c:f>template!$I$42:$Q$42</c:f>
              <c:numCache>
                <c:formatCode>General</c:formatCode>
                <c:ptCount val="9"/>
                <c:pt idx="0">
                  <c:v>113.8</c:v>
                </c:pt>
                <c:pt idx="1">
                  <c:v>521.79999999999995</c:v>
                </c:pt>
                <c:pt idx="2">
                  <c:v>541.20000000000005</c:v>
                </c:pt>
                <c:pt idx="4">
                  <c:v>422.4</c:v>
                </c:pt>
                <c:pt idx="8">
                  <c:v>17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FCC-45DF-A30E-0C32A4FFDF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2920952"/>
        <c:axId val="532921272"/>
      </c:lineChart>
      <c:catAx>
        <c:axId val="5329209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2921272"/>
        <c:crosses val="autoZero"/>
        <c:auto val="1"/>
        <c:lblAlgn val="ctr"/>
        <c:lblOffset val="100"/>
        <c:noMultiLvlLbl val="0"/>
      </c:catAx>
      <c:valAx>
        <c:axId val="532921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2920952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span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template!$H$68</c:f>
              <c:strCache>
                <c:ptCount val="1"/>
                <c:pt idx="0">
                  <c:v>f/f</c:v>
                </c:pt>
              </c:strCache>
            </c:strRef>
          </c:tx>
          <c:spPr>
            <a:ln w="63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emplate!$I$74:$Q$74</c:f>
                <c:numCache>
                  <c:formatCode>General</c:formatCode>
                  <c:ptCount val="9"/>
                  <c:pt idx="0">
                    <c:v>6.7180571348170792</c:v>
                  </c:pt>
                  <c:pt idx="1">
                    <c:v>32.622617250153304</c:v>
                  </c:pt>
                  <c:pt idx="2">
                    <c:v>33.71125862873312</c:v>
                  </c:pt>
                  <c:pt idx="4">
                    <c:v>18.957628192014596</c:v>
                  </c:pt>
                  <c:pt idx="8">
                    <c:v>6.8082173082728987</c:v>
                  </c:pt>
                </c:numCache>
              </c:numRef>
            </c:plus>
            <c:minus>
              <c:numRef>
                <c:f>template!$I$74:$Q$74</c:f>
                <c:numCache>
                  <c:formatCode>General</c:formatCode>
                  <c:ptCount val="9"/>
                  <c:pt idx="0">
                    <c:v>6.7180571348170792</c:v>
                  </c:pt>
                  <c:pt idx="1">
                    <c:v>32.622617250153304</c:v>
                  </c:pt>
                  <c:pt idx="2">
                    <c:v>33.71125862873312</c:v>
                  </c:pt>
                  <c:pt idx="4">
                    <c:v>18.957628192014596</c:v>
                  </c:pt>
                  <c:pt idx="8">
                    <c:v>6.80821730827289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template!$I$67:$Q$67</c:f>
              <c:numCache>
                <c:formatCode>General</c:formatCode>
                <c:ptCount val="9"/>
                <c:pt idx="0">
                  <c:v>0</c:v>
                </c:pt>
                <c:pt idx="2">
                  <c:v>30</c:v>
                </c:pt>
                <c:pt idx="4">
                  <c:v>60</c:v>
                </c:pt>
                <c:pt idx="6">
                  <c:v>90</c:v>
                </c:pt>
                <c:pt idx="8">
                  <c:v>120</c:v>
                </c:pt>
              </c:numCache>
            </c:numRef>
          </c:cat>
          <c:val>
            <c:numRef>
              <c:f>template!$I$68:$Q$68</c:f>
              <c:numCache>
                <c:formatCode>General</c:formatCode>
                <c:ptCount val="9"/>
                <c:pt idx="0">
                  <c:v>95.125</c:v>
                </c:pt>
                <c:pt idx="1">
                  <c:v>489.8125</c:v>
                </c:pt>
                <c:pt idx="2">
                  <c:v>476.125</c:v>
                </c:pt>
                <c:pt idx="4">
                  <c:v>267.5</c:v>
                </c:pt>
                <c:pt idx="8">
                  <c:v>126.81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D50-4CEB-B80D-9931531095B1}"/>
            </c:ext>
          </c:extLst>
        </c:ser>
        <c:ser>
          <c:idx val="1"/>
          <c:order val="1"/>
          <c:tx>
            <c:strRef>
              <c:f>template!$H$69</c:f>
              <c:strCache>
                <c:ptCount val="1"/>
                <c:pt idx="0">
                  <c:v>VeNKO</c:v>
                </c:pt>
              </c:strCache>
            </c:strRef>
          </c:tx>
          <c:spPr>
            <a:ln w="63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ysClr val="windowText" lastClr="000000"/>
              </a:solidFill>
              <a:ln w="63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emplate!$I$75:$Q$75</c:f>
                <c:numCache>
                  <c:formatCode>General</c:formatCode>
                  <c:ptCount val="9"/>
                  <c:pt idx="0">
                    <c:v>4.9047118515879689</c:v>
                  </c:pt>
                  <c:pt idx="1">
                    <c:v>28.627733187208779</c:v>
                  </c:pt>
                  <c:pt idx="2">
                    <c:v>24.80665733092394</c:v>
                  </c:pt>
                  <c:pt idx="4">
                    <c:v>27.954774574079529</c:v>
                  </c:pt>
                  <c:pt idx="8">
                    <c:v>12.445783248199245</c:v>
                  </c:pt>
                </c:numCache>
              </c:numRef>
            </c:plus>
            <c:minus>
              <c:numRef>
                <c:f>template!$I$75:$Q$75</c:f>
                <c:numCache>
                  <c:formatCode>General</c:formatCode>
                  <c:ptCount val="9"/>
                  <c:pt idx="0">
                    <c:v>4.9047118515879689</c:v>
                  </c:pt>
                  <c:pt idx="1">
                    <c:v>28.627733187208779</c:v>
                  </c:pt>
                  <c:pt idx="2">
                    <c:v>24.80665733092394</c:v>
                  </c:pt>
                  <c:pt idx="4">
                    <c:v>27.954774574079529</c:v>
                  </c:pt>
                  <c:pt idx="8">
                    <c:v>12.4457832481992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template!$I$67:$Q$67</c:f>
              <c:numCache>
                <c:formatCode>General</c:formatCode>
                <c:ptCount val="9"/>
                <c:pt idx="0">
                  <c:v>0</c:v>
                </c:pt>
                <c:pt idx="2">
                  <c:v>30</c:v>
                </c:pt>
                <c:pt idx="4">
                  <c:v>60</c:v>
                </c:pt>
                <c:pt idx="6">
                  <c:v>90</c:v>
                </c:pt>
                <c:pt idx="8">
                  <c:v>120</c:v>
                </c:pt>
              </c:numCache>
            </c:numRef>
          </c:cat>
          <c:val>
            <c:numRef>
              <c:f>template!$I$69:$Q$69</c:f>
              <c:numCache>
                <c:formatCode>General</c:formatCode>
                <c:ptCount val="9"/>
                <c:pt idx="0">
                  <c:v>95.272727272727266</c:v>
                </c:pt>
                <c:pt idx="1">
                  <c:v>452.27272727272725</c:v>
                </c:pt>
                <c:pt idx="2">
                  <c:v>471.45454545454544</c:v>
                </c:pt>
                <c:pt idx="4">
                  <c:v>292.18181818181819</c:v>
                </c:pt>
                <c:pt idx="8">
                  <c:v>148.454545454545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D50-4CEB-B80D-9931531095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2920952"/>
        <c:axId val="532921272"/>
      </c:lineChart>
      <c:catAx>
        <c:axId val="5329209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2921272"/>
        <c:crosses val="autoZero"/>
        <c:auto val="1"/>
        <c:lblAlgn val="ctr"/>
        <c:lblOffset val="100"/>
        <c:noMultiLvlLbl val="0"/>
      </c:catAx>
      <c:valAx>
        <c:axId val="532921272"/>
        <c:scaling>
          <c:orientation val="minMax"/>
          <c:max val="6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2920952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span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1625" y="0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D9D91BB7-6D9D-4300-9488-FE6F0B011AF5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62" tIns="46081" rIns="92162" bIns="4608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605" y="4780300"/>
            <a:ext cx="5441642" cy="3910864"/>
          </a:xfrm>
          <a:prstGeom prst="rect">
            <a:avLst/>
          </a:prstGeom>
        </p:spPr>
        <p:txBody>
          <a:bodyPr vert="horz" lIns="92162" tIns="46081" rIns="92162" bIns="4608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34341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1625" y="9434341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1454848C-FEA4-4A2B-87C2-C604F6929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5039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986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974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168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738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20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43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86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3916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421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8854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437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501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image" Target="../media/image1.emf"/><Relationship Id="rId21" Type="http://schemas.openxmlformats.org/officeDocument/2006/relationships/oleObject" Target="../embeddings/oleObject9.bin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chart" Target="../charts/chart2.xml"/><Relationship Id="rId25" Type="http://schemas.openxmlformats.org/officeDocument/2006/relationships/oleObject" Target="../embeddings/oleObject11.bin"/><Relationship Id="rId2" Type="http://schemas.openxmlformats.org/officeDocument/2006/relationships/oleObject" Target="../embeddings/oleObject1.bin"/><Relationship Id="rId16" Type="http://schemas.openxmlformats.org/officeDocument/2006/relationships/chart" Target="../charts/chart1.xml"/><Relationship Id="rId20" Type="http://schemas.openxmlformats.org/officeDocument/2006/relationships/image" Target="../media/image9.emf"/><Relationship Id="rId29" Type="http://schemas.openxmlformats.org/officeDocument/2006/relationships/oleObject" Target="../embeddings/oleObject13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image" Target="../media/image11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oleObject" Target="../embeddings/oleObject10.bin"/><Relationship Id="rId28" Type="http://schemas.openxmlformats.org/officeDocument/2006/relationships/image" Target="../media/image13.emf"/><Relationship Id="rId10" Type="http://schemas.openxmlformats.org/officeDocument/2006/relationships/oleObject" Target="../embeddings/oleObject5.bin"/><Relationship Id="rId19" Type="http://schemas.openxmlformats.org/officeDocument/2006/relationships/oleObject" Target="../embeddings/oleObject8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2.bin"/><Relationship Id="rId30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2152F0-F3E8-DB78-B3A9-81FDBA8FB0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24A49DD-0DD4-6AE1-9CD6-8BC418D4A202}"/>
              </a:ext>
            </a:extLst>
          </p:cNvPr>
          <p:cNvSpPr txBox="1"/>
          <p:nvPr/>
        </p:nvSpPr>
        <p:spPr>
          <a:xfrm>
            <a:off x="0" y="131437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B7AD1FAB-CC12-4891-4055-C68208A3B6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8032808"/>
              </p:ext>
            </p:extLst>
          </p:nvPr>
        </p:nvGraphicFramePr>
        <p:xfrm>
          <a:off x="3644900" y="509588"/>
          <a:ext cx="2611438" cy="1849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786719" imgH="2678834" progId="Prism8.Document">
                  <p:embed/>
                </p:oleObj>
              </mc:Choice>
              <mc:Fallback>
                <p:oleObj name="Prism 8" r:id="rId2" imgW="3786719" imgH="2678834" progId="Prism8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B7AD1FAB-CC12-4891-4055-C68208A3B6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44900" y="509588"/>
                        <a:ext cx="2611438" cy="1849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A433B56-75CC-4382-A6A1-922A512B8BA9}"/>
              </a:ext>
            </a:extLst>
          </p:cNvPr>
          <p:cNvSpPr txBox="1"/>
          <p:nvPr/>
        </p:nvSpPr>
        <p:spPr>
          <a:xfrm>
            <a:off x="963001" y="2145914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FB7D65D-8C76-B453-A7F1-474E94B498FE}"/>
              </a:ext>
            </a:extLst>
          </p:cNvPr>
          <p:cNvSpPr txBox="1"/>
          <p:nvPr/>
        </p:nvSpPr>
        <p:spPr>
          <a:xfrm>
            <a:off x="-79077" y="3868486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35" name="オブジェクト 34">
            <a:extLst>
              <a:ext uri="{FF2B5EF4-FFF2-40B4-BE49-F238E27FC236}">
                <a16:creationId xmlns:a16="http://schemas.microsoft.com/office/drawing/2014/main" id="{01739983-CE39-5693-3F58-10B8C94EFF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7281293"/>
              </p:ext>
            </p:extLst>
          </p:nvPr>
        </p:nvGraphicFramePr>
        <p:xfrm>
          <a:off x="2192338" y="6083300"/>
          <a:ext cx="2449512" cy="1846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855110" imgH="2678834" progId="Prism8.Document">
                  <p:embed/>
                </p:oleObj>
              </mc:Choice>
              <mc:Fallback>
                <p:oleObj name="Prism 8" r:id="rId4" imgW="3855110" imgH="2678834" progId="Prism8.Document">
                  <p:embed/>
                  <p:pic>
                    <p:nvPicPr>
                      <p:cNvPr id="35" name="オブジェクト 34">
                        <a:extLst>
                          <a:ext uri="{FF2B5EF4-FFF2-40B4-BE49-F238E27FC236}">
                            <a16:creationId xmlns:a16="http://schemas.microsoft.com/office/drawing/2014/main" id="{01739983-CE39-5693-3F58-10B8C94EFF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92338" y="6083300"/>
                        <a:ext cx="2449512" cy="1846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オブジェクト 35">
            <a:extLst>
              <a:ext uri="{FF2B5EF4-FFF2-40B4-BE49-F238E27FC236}">
                <a16:creationId xmlns:a16="http://schemas.microsoft.com/office/drawing/2014/main" id="{AFC35D90-AD4C-3977-687A-08C2112B05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3671448"/>
              </p:ext>
            </p:extLst>
          </p:nvPr>
        </p:nvGraphicFramePr>
        <p:xfrm>
          <a:off x="2219427" y="8110757"/>
          <a:ext cx="2433253" cy="1858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855613" imgH="2693153" progId="Prism9.Document">
                  <p:embed/>
                </p:oleObj>
              </mc:Choice>
              <mc:Fallback>
                <p:oleObj name="Prism 9" r:id="rId6" imgW="3855613" imgH="2693153" progId="Prism9.Document">
                  <p:embed/>
                  <p:pic>
                    <p:nvPicPr>
                      <p:cNvPr id="36" name="オブジェクト 35">
                        <a:extLst>
                          <a:ext uri="{FF2B5EF4-FFF2-40B4-BE49-F238E27FC236}">
                            <a16:creationId xmlns:a16="http://schemas.microsoft.com/office/drawing/2014/main" id="{AFC35D90-AD4C-3977-687A-08C2112B05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19427" y="8110757"/>
                        <a:ext cx="2433253" cy="18582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20F3D6A-E72A-52B1-0ABB-F7A93FF14D38}"/>
              </a:ext>
            </a:extLst>
          </p:cNvPr>
          <p:cNvSpPr txBox="1"/>
          <p:nvPr/>
        </p:nvSpPr>
        <p:spPr>
          <a:xfrm>
            <a:off x="4362059" y="5727385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342C0471-348A-196B-597B-70F94D5AB1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9937331"/>
              </p:ext>
            </p:extLst>
          </p:nvPr>
        </p:nvGraphicFramePr>
        <p:xfrm>
          <a:off x="4320278" y="8125217"/>
          <a:ext cx="1604962" cy="1693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2326477" imgH="2455521" progId="Prism8.Document">
                  <p:embed/>
                </p:oleObj>
              </mc:Choice>
              <mc:Fallback>
                <p:oleObj name="Prism 8" r:id="rId8" imgW="2326477" imgH="2455521" progId="Prism8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342C0471-348A-196B-597B-70F94D5AB1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320278" y="8125217"/>
                        <a:ext cx="1604962" cy="1693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70DC6F6B-46E6-CED2-44E7-6B0DC322B7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3514148"/>
              </p:ext>
            </p:extLst>
          </p:nvPr>
        </p:nvGraphicFramePr>
        <p:xfrm>
          <a:off x="4302152" y="6075037"/>
          <a:ext cx="1605269" cy="16943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326477" imgH="2455521" progId="Prism9.Document">
                  <p:embed/>
                </p:oleObj>
              </mc:Choice>
              <mc:Fallback>
                <p:oleObj name="Prism 9" r:id="rId10" imgW="2326477" imgH="2455521" progId="Prism9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70DC6F6B-46E6-CED2-44E7-6B0DC322B7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302152" y="6075037"/>
                        <a:ext cx="1605269" cy="16943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471BAD5-5AAC-4E94-C699-9F9697FDD999}"/>
              </a:ext>
            </a:extLst>
          </p:cNvPr>
          <p:cNvSpPr txBox="1"/>
          <p:nvPr/>
        </p:nvSpPr>
        <p:spPr>
          <a:xfrm>
            <a:off x="1849966" y="377658"/>
            <a:ext cx="5725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AC47997-8F29-8541-FD74-C7B80E2A5989}"/>
              </a:ext>
            </a:extLst>
          </p:cNvPr>
          <p:cNvSpPr txBox="1"/>
          <p:nvPr/>
        </p:nvSpPr>
        <p:spPr>
          <a:xfrm>
            <a:off x="4824585" y="6002949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6B1B4B5-35B9-FA85-054D-80081A5830B4}"/>
              </a:ext>
            </a:extLst>
          </p:cNvPr>
          <p:cNvSpPr txBox="1"/>
          <p:nvPr/>
        </p:nvSpPr>
        <p:spPr>
          <a:xfrm>
            <a:off x="949448" y="6002949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8BCB8F3-91BF-F95D-279F-F6FDECB231BF}"/>
              </a:ext>
            </a:extLst>
          </p:cNvPr>
          <p:cNvSpPr txBox="1"/>
          <p:nvPr/>
        </p:nvSpPr>
        <p:spPr>
          <a:xfrm>
            <a:off x="4562193" y="437384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139B96D-20CF-FA67-DC74-FDAF53849D16}"/>
              </a:ext>
            </a:extLst>
          </p:cNvPr>
          <p:cNvSpPr txBox="1"/>
          <p:nvPr/>
        </p:nvSpPr>
        <p:spPr>
          <a:xfrm>
            <a:off x="4744856" y="7978803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94A5439-B95B-122F-5FA7-254491C6E176}"/>
              </a:ext>
            </a:extLst>
          </p:cNvPr>
          <p:cNvSpPr txBox="1"/>
          <p:nvPr/>
        </p:nvSpPr>
        <p:spPr>
          <a:xfrm>
            <a:off x="861139" y="7978803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2F3E75A-783C-B767-385F-AEA3552FB516}"/>
              </a:ext>
            </a:extLst>
          </p:cNvPr>
          <p:cNvSpPr txBox="1"/>
          <p:nvPr/>
        </p:nvSpPr>
        <p:spPr>
          <a:xfrm>
            <a:off x="3308064" y="-37017"/>
            <a:ext cx="38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DAAA9C3D-AB7B-1EC8-AE0F-0E8B2479A9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7582728"/>
              </p:ext>
            </p:extLst>
          </p:nvPr>
        </p:nvGraphicFramePr>
        <p:xfrm>
          <a:off x="797153" y="509800"/>
          <a:ext cx="2611438" cy="1847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786719" imgH="2678834" progId="Prism8.Document">
                  <p:embed/>
                </p:oleObj>
              </mc:Choice>
              <mc:Fallback>
                <p:oleObj name="Prism 8" r:id="rId12" imgW="3786719" imgH="2678834" progId="Prism8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DAAA9C3D-AB7B-1EC8-AE0F-0E8B2479A9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97153" y="509800"/>
                        <a:ext cx="2611438" cy="1847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CEDDDF68-824B-98DC-4D3E-779055157D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5346067"/>
              </p:ext>
            </p:extLst>
          </p:nvPr>
        </p:nvGraphicFramePr>
        <p:xfrm>
          <a:off x="1319213" y="2276475"/>
          <a:ext cx="1995487" cy="170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892233" imgH="2470057" progId="Prism8.Document">
                  <p:embed/>
                </p:oleObj>
              </mc:Choice>
              <mc:Fallback>
                <p:oleObj name="Prism 8" r:id="rId14" imgW="2892233" imgH="2470057" progId="Prism8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CEDDDF68-824B-98DC-4D3E-779055157D6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319213" y="2276475"/>
                        <a:ext cx="1995487" cy="170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2281055"/>
              </p:ext>
            </p:extLst>
          </p:nvPr>
        </p:nvGraphicFramePr>
        <p:xfrm>
          <a:off x="45047" y="6131530"/>
          <a:ext cx="2380422" cy="1637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5757602"/>
              </p:ext>
            </p:extLst>
          </p:nvPr>
        </p:nvGraphicFramePr>
        <p:xfrm>
          <a:off x="39975" y="8102670"/>
          <a:ext cx="2433252" cy="1694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pic>
        <p:nvPicPr>
          <p:cNvPr id="18" name="図 17">
            <a:extLst>
              <a:ext uri="{FF2B5EF4-FFF2-40B4-BE49-F238E27FC236}">
                <a16:creationId xmlns:a16="http://schemas.microsoft.com/office/drawing/2014/main" id="{09C465CF-B894-E25B-69C6-084501AA7BF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198846" y="2251454"/>
            <a:ext cx="2844000" cy="1724878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7386E26-347C-AFB6-B200-1475D7EF2071}"/>
              </a:ext>
            </a:extLst>
          </p:cNvPr>
          <p:cNvSpPr txBox="1"/>
          <p:nvPr/>
        </p:nvSpPr>
        <p:spPr>
          <a:xfrm>
            <a:off x="2242838" y="3910943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15831F3-5127-FC3C-CFEA-2810D4DFA921}"/>
              </a:ext>
            </a:extLst>
          </p:cNvPr>
          <p:cNvSpPr txBox="1"/>
          <p:nvPr/>
        </p:nvSpPr>
        <p:spPr>
          <a:xfrm>
            <a:off x="-72248" y="5714888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F30979A-E80B-8FF9-C07C-43FD069A64AE}"/>
              </a:ext>
            </a:extLst>
          </p:cNvPr>
          <p:cNvSpPr txBox="1"/>
          <p:nvPr/>
        </p:nvSpPr>
        <p:spPr>
          <a:xfrm>
            <a:off x="2237880" y="5716571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0084522-6420-1218-C4D9-91335724A0D2}"/>
              </a:ext>
            </a:extLst>
          </p:cNvPr>
          <p:cNvSpPr txBox="1"/>
          <p:nvPr/>
        </p:nvSpPr>
        <p:spPr>
          <a:xfrm>
            <a:off x="3294010" y="6002949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EFAA3AA-EF0D-9596-BA73-B4E22FD3AF19}"/>
              </a:ext>
            </a:extLst>
          </p:cNvPr>
          <p:cNvSpPr txBox="1"/>
          <p:nvPr/>
        </p:nvSpPr>
        <p:spPr>
          <a:xfrm>
            <a:off x="3166028" y="7978803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C796908-05FD-74A3-429C-C5E12C49F3BC}"/>
              </a:ext>
            </a:extLst>
          </p:cNvPr>
          <p:cNvSpPr txBox="1"/>
          <p:nvPr/>
        </p:nvSpPr>
        <p:spPr>
          <a:xfrm>
            <a:off x="5560446" y="6952460"/>
            <a:ext cx="631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87E0D8A-BC33-4C89-1D61-51BA494C3C07}"/>
              </a:ext>
            </a:extLst>
          </p:cNvPr>
          <p:cNvSpPr txBox="1"/>
          <p:nvPr/>
        </p:nvSpPr>
        <p:spPr>
          <a:xfrm rot="16200000">
            <a:off x="-963467" y="6174962"/>
            <a:ext cx="2052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Glucose (mg/dL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B3CADF8-2860-2E1B-3423-E5E08EA8E3E4}"/>
              </a:ext>
            </a:extLst>
          </p:cNvPr>
          <p:cNvSpPr txBox="1"/>
          <p:nvPr/>
        </p:nvSpPr>
        <p:spPr>
          <a:xfrm rot="16200000">
            <a:off x="-973627" y="8217122"/>
            <a:ext cx="2052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Glucose (mg/dL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5ED6CA7-8196-AC0A-D0DA-75C6B21FB37B}"/>
              </a:ext>
            </a:extLst>
          </p:cNvPr>
          <p:cNvSpPr txBox="1"/>
          <p:nvPr/>
        </p:nvSpPr>
        <p:spPr>
          <a:xfrm>
            <a:off x="713998" y="7671852"/>
            <a:ext cx="2052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Time after injection (min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F0BB6F4-516D-977F-63FC-1106921F579C}"/>
              </a:ext>
            </a:extLst>
          </p:cNvPr>
          <p:cNvSpPr txBox="1"/>
          <p:nvPr/>
        </p:nvSpPr>
        <p:spPr>
          <a:xfrm>
            <a:off x="715916" y="9702741"/>
            <a:ext cx="20523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Time after injection (min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id="{09F91D79-D6DF-5089-D4C6-ECC6919070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3676507"/>
              </p:ext>
            </p:extLst>
          </p:nvPr>
        </p:nvGraphicFramePr>
        <p:xfrm>
          <a:off x="134938" y="3848100"/>
          <a:ext cx="1920875" cy="2405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9" imgW="1921436" imgH="2404544" progId="Prism9.Document">
                  <p:embed/>
                </p:oleObj>
              </mc:Choice>
              <mc:Fallback>
                <p:oleObj name="Prism 9" r:id="rId19" imgW="1921436" imgH="240454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34938" y="3848100"/>
                        <a:ext cx="1920875" cy="2405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オブジェクト 32">
            <a:extLst>
              <a:ext uri="{FF2B5EF4-FFF2-40B4-BE49-F238E27FC236}">
                <a16:creationId xmlns:a16="http://schemas.microsoft.com/office/drawing/2014/main" id="{8702DE46-632F-7FE3-C57F-732C461CA0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6105492"/>
              </p:ext>
            </p:extLst>
          </p:nvPr>
        </p:nvGraphicFramePr>
        <p:xfrm>
          <a:off x="2572068" y="3816668"/>
          <a:ext cx="2252662" cy="2208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1" imgW="2252234" imgH="2208005" progId="Prism9.Document">
                  <p:embed/>
                </p:oleObj>
              </mc:Choice>
              <mc:Fallback>
                <p:oleObj name="Prism 9" r:id="rId21" imgW="2252234" imgH="220800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572068" y="3816668"/>
                        <a:ext cx="2252662" cy="2208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オブジェクト 40">
            <a:extLst>
              <a:ext uri="{FF2B5EF4-FFF2-40B4-BE49-F238E27FC236}">
                <a16:creationId xmlns:a16="http://schemas.microsoft.com/office/drawing/2014/main" id="{9FDFC4FA-3D05-55BF-476D-B1AE058EA4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7040964"/>
              </p:ext>
            </p:extLst>
          </p:nvPr>
        </p:nvGraphicFramePr>
        <p:xfrm>
          <a:off x="5485704" y="7209666"/>
          <a:ext cx="1681635" cy="19293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3" imgW="1788973" imgH="2052501" progId="Prism9.Document">
                  <p:embed/>
                </p:oleObj>
              </mc:Choice>
              <mc:Fallback>
                <p:oleObj name="Prism 9" r:id="rId23" imgW="1788973" imgH="205250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485704" y="7209666"/>
                        <a:ext cx="1681635" cy="19293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134AD55D-E48F-B6AE-EA29-DD0D651889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7878284"/>
              </p:ext>
            </p:extLst>
          </p:nvPr>
        </p:nvGraphicFramePr>
        <p:xfrm>
          <a:off x="1440452" y="5916139"/>
          <a:ext cx="987168" cy="1140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5" imgW="2531199" imgH="2924328" progId="Prism8.Document">
                  <p:embed/>
                </p:oleObj>
              </mc:Choice>
              <mc:Fallback>
                <p:oleObj name="Prism 8" r:id="rId25" imgW="2531199" imgH="292432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440452" y="5916139"/>
                        <a:ext cx="987168" cy="1140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オブジェクト 14">
            <a:extLst>
              <a:ext uri="{FF2B5EF4-FFF2-40B4-BE49-F238E27FC236}">
                <a16:creationId xmlns:a16="http://schemas.microsoft.com/office/drawing/2014/main" id="{06B13F1F-EAB7-B37B-32C3-69919069F7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8690981"/>
              </p:ext>
            </p:extLst>
          </p:nvPr>
        </p:nvGraphicFramePr>
        <p:xfrm>
          <a:off x="1486042" y="8152182"/>
          <a:ext cx="985904" cy="11421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7" imgW="2527959" imgH="2928648" progId="Prism9.Document">
                  <p:embed/>
                </p:oleObj>
              </mc:Choice>
              <mc:Fallback>
                <p:oleObj name="Prism 9" r:id="rId27" imgW="2527959" imgH="292864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486042" y="8152182"/>
                        <a:ext cx="985904" cy="11421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オブジェクト 19">
            <a:extLst>
              <a:ext uri="{FF2B5EF4-FFF2-40B4-BE49-F238E27FC236}">
                <a16:creationId xmlns:a16="http://schemas.microsoft.com/office/drawing/2014/main" id="{B33AFE23-B488-6E5F-6C3D-2C1BA52FF5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8597136"/>
              </p:ext>
            </p:extLst>
          </p:nvPr>
        </p:nvGraphicFramePr>
        <p:xfrm>
          <a:off x="4757953" y="3721289"/>
          <a:ext cx="2236787" cy="2371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9" imgW="2237116" imgH="2371067" progId="Prism9.Document">
                  <p:embed/>
                </p:oleObj>
              </mc:Choice>
              <mc:Fallback>
                <p:oleObj name="Prism 9" r:id="rId29" imgW="2237116" imgH="237106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4757953" y="3721289"/>
                        <a:ext cx="2236787" cy="2371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81778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7</TotalTime>
  <Words>43</Words>
  <Application>Microsoft Office PowerPoint</Application>
  <PresentationFormat>A4 210 x 297 mm</PresentationFormat>
  <Paragraphs>21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Office テーマ</vt:lpstr>
      <vt:lpstr>Prism 8</vt:lpstr>
      <vt:lpstr>Prism 9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 Y</dc:creator>
  <cp:lastModifiedBy>yama1005@keio.jp</cp:lastModifiedBy>
  <cp:revision>511</cp:revision>
  <cp:lastPrinted>2025-08-07T09:30:53Z</cp:lastPrinted>
  <dcterms:created xsi:type="dcterms:W3CDTF">2020-05-07T06:16:48Z</dcterms:created>
  <dcterms:modified xsi:type="dcterms:W3CDTF">2025-09-05T14:01:56Z</dcterms:modified>
</cp:coreProperties>
</file>